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12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02967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59349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59748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81049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16660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644419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985871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33644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070928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69697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28902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45539D-3338-4496-866B-4564600B99C9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0EC33-3E97-4DA0-9F74-EBBCC28EA55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94127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IE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S2a.</a:t>
            </a:r>
            <a:r>
              <a:rPr kumimoji="0" lang="en-IE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Mean daily rainfall values taken for Oak Park (Carlow, Ireland) during 2013, 2014 and 2015</a:t>
            </a:r>
            <a:endParaRPr kumimoji="0" lang="en-IE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Picture 1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457200"/>
            <a:ext cx="9055707" cy="30438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2371725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25974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IE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S2b.</a:t>
            </a:r>
            <a:r>
              <a:rPr kumimoji="0" lang="en-IE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Mean daily temperature values taken for Oak Park (Carlow, Ireland) during 2013, 2014 and 2015</a:t>
            </a:r>
            <a:endParaRPr kumimoji="0" lang="en-IE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Picture 1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9157238" cy="28997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226695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78584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IE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S2c.</a:t>
            </a:r>
            <a:r>
              <a:rPr kumimoji="0" lang="en-IE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Mean daily soil temperature values (at 30 cm depth) taken for Oak Park (Carlow, Ireland) during 2013, 2014 and 2015.</a:t>
            </a:r>
            <a:endParaRPr kumimoji="0" lang="en-IE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Picture 1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8999873" cy="28997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2295525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IE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endParaRPr kumimoji="0" lang="en-IE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25160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IE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S2d.</a:t>
            </a:r>
            <a:r>
              <a:rPr kumimoji="0" lang="en-IE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Mean daily relative humidity values for Oak Park (Carlow, Ireland) during 2013, 2014 and 2015. </a:t>
            </a:r>
            <a:endParaRPr kumimoji="0" lang="en-IE" sz="6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E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Picture 2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8990826" cy="297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2333625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3818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8</Words>
  <Application>Microsoft Office PowerPoint</Application>
  <PresentationFormat>On-screen Show (4:3)</PresentationFormat>
  <Paragraphs>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Teaga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wen Mullins</dc:creator>
  <cp:lastModifiedBy>Ewen Mullins</cp:lastModifiedBy>
  <cp:revision>2</cp:revision>
  <dcterms:created xsi:type="dcterms:W3CDTF">2016-11-17T13:41:20Z</dcterms:created>
  <dcterms:modified xsi:type="dcterms:W3CDTF">2016-11-17T13:47:05Z</dcterms:modified>
</cp:coreProperties>
</file>